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5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5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fsx21\KIND-DAT\Gruppen\xStoffForscher\P%20R%20O%20J%20E%20K%20T%20E\__PROJEKTE_NICHT%20GEF&#214;RDERT\ESPED_ALF_2016\DISSERTATION%20ABDULAZIZ\Schreiben\Material\Results\2023%2008%2011%20DiagrammeResults_M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766022250949974"/>
          <c:y val="0.31831619704561726"/>
          <c:w val="0.7917427625651271"/>
          <c:h val="0.60482787792021864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Tabelle1!$S$141:$S$148</c:f>
              <c:strCache>
                <c:ptCount val="8"/>
                <c:pt idx="0">
                  <c:v>Group cell necrosis</c:v>
                </c:pt>
                <c:pt idx="1">
                  <c:v>Single cell necrosis</c:v>
                </c:pt>
                <c:pt idx="2">
                  <c:v>Cirrhosis</c:v>
                </c:pt>
                <c:pt idx="3">
                  <c:v>Severe fibrosis</c:v>
                </c:pt>
                <c:pt idx="4">
                  <c:v>Moderate fibrosis</c:v>
                </c:pt>
                <c:pt idx="5">
                  <c:v>Mild fibrosis</c:v>
                </c:pt>
                <c:pt idx="6">
                  <c:v>Large droplet steatosis</c:v>
                </c:pt>
                <c:pt idx="7">
                  <c:v>Small droplet steatosis</c:v>
                </c:pt>
              </c:strCache>
            </c:strRef>
          </c:cat>
          <c:val>
            <c:numRef>
              <c:f>Tabelle1!$T$141:$T$148</c:f>
              <c:numCache>
                <c:formatCode>General</c:formatCode>
                <c:ptCount val="8"/>
                <c:pt idx="0">
                  <c:v>15</c:v>
                </c:pt>
                <c:pt idx="1">
                  <c:v>9</c:v>
                </c:pt>
                <c:pt idx="2">
                  <c:v>9</c:v>
                </c:pt>
                <c:pt idx="3">
                  <c:v>3</c:v>
                </c:pt>
                <c:pt idx="4">
                  <c:v>7</c:v>
                </c:pt>
                <c:pt idx="5">
                  <c:v>8</c:v>
                </c:pt>
                <c:pt idx="6">
                  <c:v>2</c:v>
                </c:pt>
                <c:pt idx="7">
                  <c:v>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61F-428E-8252-85DAF986C12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700245928"/>
        <c:axId val="700251832"/>
      </c:barChart>
      <c:catAx>
        <c:axId val="70024592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700251832"/>
        <c:crosses val="autoZero"/>
        <c:auto val="1"/>
        <c:lblAlgn val="ctr"/>
        <c:lblOffset val="100"/>
        <c:noMultiLvlLbl val="0"/>
      </c:catAx>
      <c:valAx>
        <c:axId val="70025183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7002459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withinLinear" id="16">
  <a:schemeClr val="accent3"/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56FF287-390E-424C-BEAD-ED368874D68C}" type="datetimeFigureOut">
              <a:rPr lang="de-DE" smtClean="0"/>
              <a:t>18.10.2024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088A2EA-07A3-4F2D-BDD3-B260DC363C8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946683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DDF69EF-3E45-49DF-B609-25F5C3319266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7469818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6628BB2-486C-4241-86E5-A6F9A5E4C2D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F8870D5D-F6AB-4221-9716-B7954942264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FD036B5-5A5E-47F2-8466-4DA29BB866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D69627-5F60-440D-B02D-9D22B927D63E}" type="datetimeFigureOut">
              <a:rPr lang="de-DE" smtClean="0"/>
              <a:t>18.10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87E6108-6671-4B14-B228-C3D76C510E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68C5C2D-5A0E-4B42-85E6-0F26C5DAE6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09657D-13F2-4513-9C3B-B1CC81B09A5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880819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99F8A70-56D2-4381-BB71-FD5F35C042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3B45EBEB-3D2B-4DB0-9A2B-3B36503EB7E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EDF2B35-95EF-4516-9955-2C1C1B97E2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D69627-5F60-440D-B02D-9D22B927D63E}" type="datetimeFigureOut">
              <a:rPr lang="de-DE" smtClean="0"/>
              <a:t>18.10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1C22E1E-A2B4-4E6B-84F6-3B5ACF30E9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55672B8-BBF7-45C5-80FC-52EF3BE9A3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09657D-13F2-4513-9C3B-B1CC81B09A5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676771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A51516D4-3AF5-48AD-8E48-7923EDDDFDC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400A7800-4261-4DFF-AFC4-D7BC58ECB3E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5DBF1E0-645A-495A-BE2E-148BFD2A61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D69627-5F60-440D-B02D-9D22B927D63E}" type="datetimeFigureOut">
              <a:rPr lang="de-DE" smtClean="0"/>
              <a:t>18.10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2F03EF2-66D5-4B82-A2ED-48DA71E5A3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6B77E4CB-709F-4274-8F87-F56B94DCB7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09657D-13F2-4513-9C3B-B1CC81B09A5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988541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CE22265-5570-4509-9419-EBAC6C0690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2EFB51AD-0DD4-42F8-ABFA-E3098522C8F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40C5A7D-7EC6-43E6-8892-1C181B5BBF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D69627-5F60-440D-B02D-9D22B927D63E}" type="datetimeFigureOut">
              <a:rPr lang="de-DE" smtClean="0"/>
              <a:t>18.10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E136821-B7F1-49DD-9F4F-A6F27EE145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CCF8CB6-C11A-4971-B7DE-C2DF3D2867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09657D-13F2-4513-9C3B-B1CC81B09A5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100068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68B53B7-FA4D-414B-83DA-B0D3FF3563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82718DFD-2448-44E0-9CEB-6773542478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43DB29D-103C-4F69-9070-009C9DEE56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D69627-5F60-440D-B02D-9D22B927D63E}" type="datetimeFigureOut">
              <a:rPr lang="de-DE" smtClean="0"/>
              <a:t>18.10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1811262-1BC0-42FC-A869-2FB9D0CC93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4E79266-2743-441B-8FF2-698481DA58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09657D-13F2-4513-9C3B-B1CC81B09A5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692564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AFE881F-A5EB-4754-87EC-DE8D9275E8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29F7C571-9760-494D-8F0C-AAE89A9EC81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FDEFC1DF-C184-4F5B-B08C-A612223BD68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602050BE-9AD7-42C9-83EC-BFFA05A282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D69627-5F60-440D-B02D-9D22B927D63E}" type="datetimeFigureOut">
              <a:rPr lang="de-DE" smtClean="0"/>
              <a:t>18.10.20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16C65C54-E4E8-402C-8EF1-4C24038F62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1A787497-CB5D-4722-A8D8-67C8A4C707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09657D-13F2-4513-9C3B-B1CC81B09A5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057640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EAECDA0-E365-4E67-B30B-FBAECBB000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EA04F701-BAA8-4B58-93E3-CE931E8DE8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225A631E-4340-4374-B5DF-4DD096EB2AA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54DE41E2-E52F-49A1-8E2C-B8387F268EA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8E9D4609-BE8F-4B52-975D-4D8D7FC6243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7502DFCB-C7EC-49B7-A62F-10B905B6AE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D69627-5F60-440D-B02D-9D22B927D63E}" type="datetimeFigureOut">
              <a:rPr lang="de-DE" smtClean="0"/>
              <a:t>18.10.2024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92D4F09B-EACC-470B-AC05-5A7211E5FA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7A76AC66-1287-473E-B7C0-C7CAA74A5F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09657D-13F2-4513-9C3B-B1CC81B09A5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792100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76A0D18-732C-4776-8102-61F3F6F282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C7FEACA4-FB0E-4BB7-8727-A231F72816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D69627-5F60-440D-B02D-9D22B927D63E}" type="datetimeFigureOut">
              <a:rPr lang="de-DE" smtClean="0"/>
              <a:t>18.10.2024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25F43B7D-CBE3-466D-954D-EC4F48E03E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3ADE0692-EB0E-4F9F-A162-182F4E7DD6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09657D-13F2-4513-9C3B-B1CC81B09A5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610528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4ED73195-9833-43DC-BEF5-4EEEB9083A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D69627-5F60-440D-B02D-9D22B927D63E}" type="datetimeFigureOut">
              <a:rPr lang="de-DE" smtClean="0"/>
              <a:t>18.10.2024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74A96058-0B22-4D8C-B0ED-72DA44A4A4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2A2EDBCB-7B97-4354-9B08-2A5F22CF7A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09657D-13F2-4513-9C3B-B1CC81B09A5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5242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22721CA-D86E-4210-AC4F-8DE23152D7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2F92D2BD-177A-4CDD-B0CE-D145B59A6DD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7DFCC48D-031F-4FE4-AF67-B30A10C5D11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347BF688-67C1-417F-86B0-9CA20DD7C5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D69627-5F60-440D-B02D-9D22B927D63E}" type="datetimeFigureOut">
              <a:rPr lang="de-DE" smtClean="0"/>
              <a:t>18.10.20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6E143694-D593-432B-B44D-AA95F4646A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67B21A77-4DA2-494E-8735-AD1AF42CBD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09657D-13F2-4513-9C3B-B1CC81B09A5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853823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6EED984-DBE4-4273-842A-2F716A499B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CF0A8355-6112-408C-B3C9-23A9A57F36E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66AB5E57-2345-49F2-A1FF-ECEF26BEC77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19F63949-D3F2-4892-9979-4659744DEC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D69627-5F60-440D-B02D-9D22B927D63E}" type="datetimeFigureOut">
              <a:rPr lang="de-DE" smtClean="0"/>
              <a:t>18.10.20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DBFD3440-2915-4AE8-98B0-6FA22F33C8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8F3A7A4B-D910-4FC9-A2FB-E1B257CF1B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09657D-13F2-4513-9C3B-B1CC81B09A5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833665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0CB0B67D-8858-4949-9D40-60FC61089E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EF5ECD3B-7BE3-46B3-9B4F-57555D5358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6C812AC-D235-4D80-80F8-0C645939F4B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D69627-5F60-440D-B02D-9D22B927D63E}" type="datetimeFigureOut">
              <a:rPr lang="de-DE" smtClean="0"/>
              <a:t>18.10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4792FB16-1179-4DA1-A2C3-36794FFA0EF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90CDB4C-A50D-465A-A5DE-F871E04BB98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09657D-13F2-4513-9C3B-B1CC81B09A5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157255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Diagramm 3">
            <a:extLst>
              <a:ext uri="{FF2B5EF4-FFF2-40B4-BE49-F238E27FC236}">
                <a16:creationId xmlns:a16="http://schemas.microsoft.com/office/drawing/2014/main" id="{5428DC93-B292-43A5-9817-33D76BEF6A5E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76717" y="-1248229"/>
          <a:ext cx="11912083" cy="70902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" name="Rechteck 2">
            <a:extLst>
              <a:ext uri="{FF2B5EF4-FFF2-40B4-BE49-F238E27FC236}">
                <a16:creationId xmlns:a16="http://schemas.microsoft.com/office/drawing/2014/main" id="{B8E34041-AE75-469A-A994-40B097BAAF62}"/>
              </a:ext>
            </a:extLst>
          </p:cNvPr>
          <p:cNvSpPr/>
          <p:nvPr/>
        </p:nvSpPr>
        <p:spPr>
          <a:xfrm>
            <a:off x="76717" y="54610"/>
            <a:ext cx="293785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Figure S1. </a:t>
            </a:r>
            <a:r>
              <a:rPr lang="de-DE" dirty="0" err="1"/>
              <a:t>Liver</a:t>
            </a:r>
            <a:r>
              <a:rPr lang="de-DE" dirty="0"/>
              <a:t> </a:t>
            </a:r>
            <a:r>
              <a:rPr lang="de-DE" dirty="0" err="1"/>
              <a:t>biopsy</a:t>
            </a:r>
            <a:r>
              <a:rPr lang="de-DE" dirty="0"/>
              <a:t> </a:t>
            </a:r>
            <a:r>
              <a:rPr lang="de-DE" dirty="0" err="1"/>
              <a:t>results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4427211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</Words>
  <Application>Microsoft Office PowerPoint</Application>
  <PresentationFormat>Breitbild</PresentationFormat>
  <Paragraphs>2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enz, Dominic</dc:creator>
  <cp:lastModifiedBy>Lenz, Dominic</cp:lastModifiedBy>
  <cp:revision>1</cp:revision>
  <dcterms:created xsi:type="dcterms:W3CDTF">2024-10-18T20:25:19Z</dcterms:created>
  <dcterms:modified xsi:type="dcterms:W3CDTF">2024-10-18T20:25:55Z</dcterms:modified>
</cp:coreProperties>
</file>